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424" y="-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780661070222462"/>
          <c:y val="5.0462360930501375E-2"/>
          <c:w val="0.76102108675701741"/>
          <c:h val="0.80566608871550349"/>
        </c:manualLayout>
      </c:layout>
      <c:lineChart>
        <c:grouping val="standard"/>
        <c:varyColors val="0"/>
        <c:ser>
          <c:idx val="1"/>
          <c:order val="0"/>
          <c:tx>
            <c:strRef>
              <c:f>densMeansGroups!$E$59</c:f>
              <c:strCache>
                <c:ptCount val="1"/>
                <c:pt idx="0">
                  <c:v>sensitive</c:v>
                </c:pt>
              </c:strCache>
            </c:strRef>
          </c:tx>
          <c:spPr>
            <a:ln>
              <a:noFill/>
            </a:ln>
          </c:spPr>
          <c:marker>
            <c:symbol val="diamond"/>
            <c:size val="6"/>
            <c:spPr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ensMeansGroups!$F$66:$I$66</c:f>
                <c:numCache>
                  <c:formatCode>General</c:formatCode>
                  <c:ptCount val="4"/>
                  <c:pt idx="0">
                    <c:v>3.3502000000000001</c:v>
                  </c:pt>
                  <c:pt idx="1">
                    <c:v>4.2039</c:v>
                  </c:pt>
                  <c:pt idx="2">
                    <c:v>1.6895</c:v>
                  </c:pt>
                  <c:pt idx="3">
                    <c:v>1.079</c:v>
                  </c:pt>
                </c:numCache>
              </c:numRef>
            </c:plus>
            <c:minus>
              <c:numRef>
                <c:f>densMeansGroups!$F$66:$I$66</c:f>
                <c:numCache>
                  <c:formatCode>General</c:formatCode>
                  <c:ptCount val="4"/>
                  <c:pt idx="0">
                    <c:v>3.3502000000000001</c:v>
                  </c:pt>
                  <c:pt idx="1">
                    <c:v>4.2039</c:v>
                  </c:pt>
                  <c:pt idx="2">
                    <c:v>1.6895</c:v>
                  </c:pt>
                  <c:pt idx="3">
                    <c:v>1.079</c:v>
                  </c:pt>
                </c:numCache>
              </c:numRef>
            </c:minus>
          </c:errBars>
          <c:cat>
            <c:numRef>
              <c:f>densMeansGroups!$F$58:$I$58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densMeansGroups!$F$59:$I$59</c:f>
              <c:numCache>
                <c:formatCode>#,##0.00_);[Red]\(#,##0.00\)</c:formatCode>
                <c:ptCount val="4"/>
                <c:pt idx="0">
                  <c:v>44.652000000000001</c:v>
                </c:pt>
                <c:pt idx="1">
                  <c:v>47.802999999999997</c:v>
                </c:pt>
                <c:pt idx="2">
                  <c:v>28.724</c:v>
                </c:pt>
                <c:pt idx="3">
                  <c:v>16.163</c:v>
                </c:pt>
              </c:numCache>
            </c:numRef>
          </c:val>
          <c:smooth val="0"/>
        </c:ser>
        <c:ser>
          <c:idx val="2"/>
          <c:order val="1"/>
          <c:tx>
            <c:strRef>
              <c:f>densMeansGroups!$E$60</c:f>
              <c:strCache>
                <c:ptCount val="1"/>
                <c:pt idx="0">
                  <c:v>tolerant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6"/>
          </c:marker>
          <c:errBars>
            <c:errDir val="y"/>
            <c:errBarType val="both"/>
            <c:errValType val="cust"/>
            <c:noEndCap val="0"/>
            <c:plus>
              <c:numRef>
                <c:f>densMeansGroups!$F$67:$I$67</c:f>
                <c:numCache>
                  <c:formatCode>General</c:formatCode>
                  <c:ptCount val="4"/>
                  <c:pt idx="0">
                    <c:v>8.5259</c:v>
                  </c:pt>
                  <c:pt idx="1">
                    <c:v>5.9897999999999998</c:v>
                  </c:pt>
                  <c:pt idx="2">
                    <c:v>1.6506000000000001</c:v>
                  </c:pt>
                  <c:pt idx="3">
                    <c:v>3.1894</c:v>
                  </c:pt>
                </c:numCache>
              </c:numRef>
            </c:plus>
            <c:minus>
              <c:numRef>
                <c:f>densMeansGroups!$F$67:$I$67</c:f>
                <c:numCache>
                  <c:formatCode>General</c:formatCode>
                  <c:ptCount val="4"/>
                  <c:pt idx="0">
                    <c:v>8.5259</c:v>
                  </c:pt>
                  <c:pt idx="1">
                    <c:v>5.9897999999999998</c:v>
                  </c:pt>
                  <c:pt idx="2">
                    <c:v>1.6506000000000001</c:v>
                  </c:pt>
                  <c:pt idx="3">
                    <c:v>3.1894</c:v>
                  </c:pt>
                </c:numCache>
              </c:numRef>
            </c:minus>
          </c:errBars>
          <c:cat>
            <c:numRef>
              <c:f>densMeansGroups!$F$58:$I$58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densMeansGroups!$F$60:$I$60</c:f>
              <c:numCache>
                <c:formatCode>#,##0.00_);[Red]\(#,##0.00\)</c:formatCode>
                <c:ptCount val="4"/>
                <c:pt idx="0">
                  <c:v>65.629000000000005</c:v>
                </c:pt>
                <c:pt idx="1">
                  <c:v>45.386000000000003</c:v>
                </c:pt>
                <c:pt idx="2">
                  <c:v>27.413</c:v>
                </c:pt>
                <c:pt idx="3">
                  <c:v>21.6039999999999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0619776"/>
        <c:axId val="100621312"/>
      </c:lineChart>
      <c:catAx>
        <c:axId val="1006197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100621312"/>
        <c:crosses val="autoZero"/>
        <c:auto val="1"/>
        <c:lblAlgn val="ctr"/>
        <c:lblOffset val="100"/>
        <c:noMultiLvlLbl val="0"/>
      </c:catAx>
      <c:valAx>
        <c:axId val="1006213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 sz="1100" b="0"/>
                </a:pPr>
                <a:r>
                  <a:rPr lang="en-US" altLang="ja-JP" sz="1100" b="0" i="0" baseline="0">
                    <a:effectLst/>
                  </a:rPr>
                  <a:t>Zn uptake (µg plant</a:t>
                </a:r>
                <a:r>
                  <a:rPr lang="en-US" altLang="ja-JP" sz="1100" b="0" i="0" baseline="30000">
                    <a:effectLst/>
                  </a:rPr>
                  <a:t>-1</a:t>
                </a:r>
                <a:r>
                  <a:rPr lang="en-US" altLang="ja-JP" sz="1100" b="0" i="0" baseline="0">
                    <a:effectLst/>
                  </a:rPr>
                  <a:t>)</a:t>
                </a:r>
                <a:endParaRPr lang="ja-JP" altLang="ja-JP" sz="1100" b="0">
                  <a:effectLst/>
                </a:endParaRPr>
              </a:p>
            </c:rich>
          </c:tx>
          <c:layout>
            <c:manualLayout>
              <c:xMode val="edge"/>
              <c:yMode val="edge"/>
              <c:x val="0"/>
              <c:y val="0.1657884486098849"/>
            </c:manualLayout>
          </c:layout>
          <c:overlay val="0"/>
        </c:title>
        <c:numFmt formatCode="#,##0_);[Red]\(#,##0\)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10061977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0096731045706606"/>
          <c:y val="0.76322647201545157"/>
          <c:w val="0.60381347670213614"/>
          <c:h val="8.0535148480950308E-2"/>
        </c:manualLayout>
      </c:layout>
      <c:overlay val="0"/>
      <c:txPr>
        <a:bodyPr/>
        <a:lstStyle/>
        <a:p>
          <a:pPr>
            <a:defRPr lang="ja-JP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05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736029016458754"/>
          <c:y val="5.0462360930501375E-2"/>
          <c:w val="0.7940382317801673"/>
          <c:h val="0.80566608871550349"/>
        </c:manualLayout>
      </c:layout>
      <c:lineChart>
        <c:grouping val="standard"/>
        <c:varyColors val="0"/>
        <c:ser>
          <c:idx val="1"/>
          <c:order val="0"/>
          <c:tx>
            <c:strRef>
              <c:f>densMeansGroups!$E$61</c:f>
              <c:strCache>
                <c:ptCount val="1"/>
                <c:pt idx="0">
                  <c:v>Sensitive</c:v>
                </c:pt>
              </c:strCache>
            </c:strRef>
          </c:tx>
          <c:spPr>
            <a:ln>
              <a:noFill/>
            </a:ln>
          </c:spPr>
          <c:marker>
            <c:symbol val="diamond"/>
            <c:size val="6"/>
            <c:spPr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ensMeansGroups!$F$68:$I$68</c:f>
                <c:numCache>
                  <c:formatCode>General</c:formatCode>
                  <c:ptCount val="4"/>
                  <c:pt idx="0">
                    <c:v>5.3900000000000003E-2</c:v>
                  </c:pt>
                  <c:pt idx="1">
                    <c:v>3.9199999999999999E-2</c:v>
                  </c:pt>
                  <c:pt idx="2">
                    <c:v>3.1600000000000003E-2</c:v>
                  </c:pt>
                  <c:pt idx="3">
                    <c:v>1.15E-2</c:v>
                  </c:pt>
                </c:numCache>
              </c:numRef>
            </c:plus>
            <c:minus>
              <c:numRef>
                <c:f>densMeansGroups!$F$68:$I$68</c:f>
                <c:numCache>
                  <c:formatCode>General</c:formatCode>
                  <c:ptCount val="4"/>
                  <c:pt idx="0">
                    <c:v>5.3900000000000003E-2</c:v>
                  </c:pt>
                  <c:pt idx="1">
                    <c:v>3.9199999999999999E-2</c:v>
                  </c:pt>
                  <c:pt idx="2">
                    <c:v>3.1600000000000003E-2</c:v>
                  </c:pt>
                  <c:pt idx="3">
                    <c:v>1.15E-2</c:v>
                  </c:pt>
                </c:numCache>
              </c:numRef>
            </c:minus>
          </c:errBars>
          <c:cat>
            <c:numRef>
              <c:f>densMeansGroups!$F$58:$I$58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densMeansGroups!$F$61:$I$61</c:f>
              <c:numCache>
                <c:formatCode>#,##0.00_);[Red]\(#,##0.00\)</c:formatCode>
                <c:ptCount val="4"/>
                <c:pt idx="0">
                  <c:v>0.44750000000000001</c:v>
                </c:pt>
                <c:pt idx="1">
                  <c:v>0.50580000000000003</c:v>
                </c:pt>
                <c:pt idx="2">
                  <c:v>0.35170000000000001</c:v>
                </c:pt>
                <c:pt idx="3">
                  <c:v>0.20080000000000001</c:v>
                </c:pt>
              </c:numCache>
            </c:numRef>
          </c:val>
          <c:smooth val="0"/>
        </c:ser>
        <c:ser>
          <c:idx val="2"/>
          <c:order val="1"/>
          <c:tx>
            <c:strRef>
              <c:f>densMeansGroups!$E$62</c:f>
              <c:strCache>
                <c:ptCount val="1"/>
                <c:pt idx="0">
                  <c:v>Tolerant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6"/>
          </c:marker>
          <c:errBars>
            <c:errDir val="y"/>
            <c:errBarType val="both"/>
            <c:errValType val="cust"/>
            <c:noEndCap val="0"/>
            <c:plus>
              <c:numRef>
                <c:f>densMeansGroups!$F$69:$I$69</c:f>
                <c:numCache>
                  <c:formatCode>General</c:formatCode>
                  <c:ptCount val="4"/>
                  <c:pt idx="0">
                    <c:v>9.6699999999999994E-2</c:v>
                  </c:pt>
                  <c:pt idx="1">
                    <c:v>7.2700000000000001E-2</c:v>
                  </c:pt>
                  <c:pt idx="2">
                    <c:v>6.0600000000000001E-2</c:v>
                  </c:pt>
                  <c:pt idx="3">
                    <c:v>5.5300000000000002E-2</c:v>
                  </c:pt>
                </c:numCache>
              </c:numRef>
            </c:plus>
            <c:minus>
              <c:numRef>
                <c:f>densMeansGroups!$F$69:$I$69</c:f>
                <c:numCache>
                  <c:formatCode>General</c:formatCode>
                  <c:ptCount val="4"/>
                  <c:pt idx="0">
                    <c:v>9.6699999999999994E-2</c:v>
                  </c:pt>
                  <c:pt idx="1">
                    <c:v>7.2700000000000001E-2</c:v>
                  </c:pt>
                  <c:pt idx="2">
                    <c:v>6.0600000000000001E-2</c:v>
                  </c:pt>
                  <c:pt idx="3">
                    <c:v>5.5300000000000002E-2</c:v>
                  </c:pt>
                </c:numCache>
              </c:numRef>
            </c:minus>
          </c:errBars>
          <c:cat>
            <c:numRef>
              <c:f>densMeansGroups!$F$58:$I$58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densMeansGroups!$F$62:$I$62</c:f>
              <c:numCache>
                <c:formatCode>#,##0.00_);[Red]\(#,##0.00\)</c:formatCode>
                <c:ptCount val="4"/>
                <c:pt idx="0">
                  <c:v>0.69630000000000003</c:v>
                </c:pt>
                <c:pt idx="1">
                  <c:v>0.49380000000000002</c:v>
                </c:pt>
                <c:pt idx="2">
                  <c:v>0.50249999999999995</c:v>
                </c:pt>
                <c:pt idx="3">
                  <c:v>0.343799999999999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0446976"/>
        <c:axId val="100448512"/>
      </c:lineChart>
      <c:catAx>
        <c:axId val="1004469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100448512"/>
        <c:crosses val="autoZero"/>
        <c:auto val="1"/>
        <c:lblAlgn val="ctr"/>
        <c:lblOffset val="100"/>
        <c:noMultiLvlLbl val="0"/>
      </c:catAx>
      <c:valAx>
        <c:axId val="100448512"/>
        <c:scaling>
          <c:orientation val="minMax"/>
          <c:max val="0.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 sz="1100" b="0"/>
                </a:pPr>
                <a:r>
                  <a:rPr lang="en-US" altLang="ja-JP" sz="1100" b="0" i="0" baseline="0">
                    <a:effectLst/>
                  </a:rPr>
                  <a:t>Root biomass (g plant</a:t>
                </a:r>
                <a:r>
                  <a:rPr lang="en-US" altLang="ja-JP" sz="1100" b="0" i="0" baseline="30000">
                    <a:effectLst/>
                  </a:rPr>
                  <a:t>-1</a:t>
                </a:r>
                <a:r>
                  <a:rPr lang="en-US" altLang="ja-JP" sz="1100" b="0" i="0" baseline="0">
                    <a:effectLst/>
                  </a:rPr>
                  <a:t>)</a:t>
                </a:r>
                <a:endParaRPr lang="ja-JP" altLang="ja-JP" sz="1100" b="0">
                  <a:effectLst/>
                </a:endParaRPr>
              </a:p>
            </c:rich>
          </c:tx>
          <c:layout>
            <c:manualLayout>
              <c:xMode val="edge"/>
              <c:yMode val="edge"/>
              <c:x val="8.5364396654719239E-4"/>
              <c:y val="0.13773370900158938"/>
            </c:manualLayout>
          </c:layout>
          <c:overlay val="0"/>
        </c:title>
        <c:numFmt formatCode="#,##0.0_);[Red]\(#,##0.0\)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100446976"/>
        <c:crosses val="autoZero"/>
        <c:crossBetween val="between"/>
        <c:majorUnit val="0.2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05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450439702962865"/>
          <c:y val="5.0462360930501375E-2"/>
          <c:w val="0.75689386846640327"/>
          <c:h val="0.80566608871550349"/>
        </c:manualLayout>
      </c:layout>
      <c:lineChart>
        <c:grouping val="standard"/>
        <c:varyColors val="0"/>
        <c:ser>
          <c:idx val="1"/>
          <c:order val="0"/>
          <c:tx>
            <c:strRef>
              <c:f>densMeansGroups!$E$63</c:f>
              <c:strCache>
                <c:ptCount val="1"/>
                <c:pt idx="0">
                  <c:v>Sensitive</c:v>
                </c:pt>
              </c:strCache>
            </c:strRef>
          </c:tx>
          <c:spPr>
            <a:ln>
              <a:noFill/>
            </a:ln>
          </c:spPr>
          <c:marker>
            <c:symbol val="diamond"/>
            <c:size val="6"/>
            <c:spPr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ensMeansGroups!$F$70:$I$70</c:f>
                <c:numCache>
                  <c:formatCode>General</c:formatCode>
                  <c:ptCount val="4"/>
                  <c:pt idx="0">
                    <c:v>8.3137000000000008</c:v>
                  </c:pt>
                  <c:pt idx="1">
                    <c:v>8.6202000000000005</c:v>
                  </c:pt>
                  <c:pt idx="2">
                    <c:v>6.0547000000000004</c:v>
                  </c:pt>
                  <c:pt idx="3">
                    <c:v>4.1982999999999997</c:v>
                  </c:pt>
                </c:numCache>
              </c:numRef>
            </c:plus>
            <c:minus>
              <c:numRef>
                <c:f>densMeansGroups!$F$70:$I$70</c:f>
                <c:numCache>
                  <c:formatCode>General</c:formatCode>
                  <c:ptCount val="4"/>
                  <c:pt idx="0">
                    <c:v>8.3137000000000008</c:v>
                  </c:pt>
                  <c:pt idx="1">
                    <c:v>8.6202000000000005</c:v>
                  </c:pt>
                  <c:pt idx="2">
                    <c:v>6.0547000000000004</c:v>
                  </c:pt>
                  <c:pt idx="3">
                    <c:v>4.1982999999999997</c:v>
                  </c:pt>
                </c:numCache>
              </c:numRef>
            </c:minus>
          </c:errBars>
          <c:cat>
            <c:numRef>
              <c:f>densMeansGroups!$F$58:$I$58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densMeansGroups!$F$63:$I$63</c:f>
              <c:numCache>
                <c:formatCode>#,##0.00_);[Red]\(#,##0.00\)</c:formatCode>
                <c:ptCount val="4"/>
                <c:pt idx="0">
                  <c:v>103.28</c:v>
                </c:pt>
                <c:pt idx="1">
                  <c:v>98.221000000000004</c:v>
                </c:pt>
                <c:pt idx="2">
                  <c:v>86.126000000000005</c:v>
                </c:pt>
                <c:pt idx="3">
                  <c:v>81.046999999999997</c:v>
                </c:pt>
              </c:numCache>
            </c:numRef>
          </c:val>
          <c:smooth val="0"/>
        </c:ser>
        <c:ser>
          <c:idx val="2"/>
          <c:order val="1"/>
          <c:tx>
            <c:strRef>
              <c:f>densMeansGroups!$E$64</c:f>
              <c:strCache>
                <c:ptCount val="1"/>
                <c:pt idx="0">
                  <c:v>Tolerant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6"/>
            <c:spPr>
              <a:ln>
                <a:solidFill>
                  <a:schemeClr val="dk1">
                    <a:tint val="78000"/>
                    <a:shade val="95000"/>
                    <a:satMod val="10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ensMeansGroups!$F$71:$I$71</c:f>
                <c:numCache>
                  <c:formatCode>General</c:formatCode>
                  <c:ptCount val="4"/>
                  <c:pt idx="0">
                    <c:v>4.0488</c:v>
                  </c:pt>
                  <c:pt idx="1">
                    <c:v>7.6108000000000002</c:v>
                  </c:pt>
                  <c:pt idx="2">
                    <c:v>6.7108999999999996</c:v>
                  </c:pt>
                  <c:pt idx="3">
                    <c:v>7.5621</c:v>
                  </c:pt>
                </c:numCache>
              </c:numRef>
            </c:plus>
            <c:minus>
              <c:numRef>
                <c:f>densMeansGroups!$F$71:$I$71</c:f>
                <c:numCache>
                  <c:formatCode>General</c:formatCode>
                  <c:ptCount val="4"/>
                  <c:pt idx="0">
                    <c:v>4.0488</c:v>
                  </c:pt>
                  <c:pt idx="1">
                    <c:v>7.6108000000000002</c:v>
                  </c:pt>
                  <c:pt idx="2">
                    <c:v>6.7108999999999996</c:v>
                  </c:pt>
                  <c:pt idx="3">
                    <c:v>7.5621</c:v>
                  </c:pt>
                </c:numCache>
              </c:numRef>
            </c:minus>
          </c:errBars>
          <c:cat>
            <c:numRef>
              <c:f>densMeansGroups!$F$58:$I$58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densMeansGroups!$F$64:$I$64</c:f>
              <c:numCache>
                <c:formatCode>#,##0.00_);[Red]\(#,##0.00\)</c:formatCode>
                <c:ptCount val="4"/>
                <c:pt idx="0">
                  <c:v>96.228999999999999</c:v>
                </c:pt>
                <c:pt idx="1">
                  <c:v>96.21</c:v>
                </c:pt>
                <c:pt idx="2">
                  <c:v>59.381999999999998</c:v>
                </c:pt>
                <c:pt idx="3">
                  <c:v>67.59399999999999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0912512"/>
        <c:axId val="100918400"/>
      </c:lineChart>
      <c:catAx>
        <c:axId val="10091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100918400"/>
        <c:crosses val="autoZero"/>
        <c:auto val="1"/>
        <c:lblAlgn val="ctr"/>
        <c:lblOffset val="100"/>
        <c:noMultiLvlLbl val="0"/>
      </c:catAx>
      <c:valAx>
        <c:axId val="1009184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 sz="1100" b="0"/>
                </a:pPr>
                <a:r>
                  <a:rPr lang="en-US" altLang="ja-JP" sz="1100" b="0" i="0" baseline="0">
                    <a:effectLst/>
                  </a:rPr>
                  <a:t>Root efficiency (µg Zn g</a:t>
                </a:r>
                <a:r>
                  <a:rPr lang="en-US" altLang="ja-JP" sz="1100" b="0" i="0" baseline="30000">
                    <a:effectLst/>
                  </a:rPr>
                  <a:t>-1</a:t>
                </a:r>
                <a:r>
                  <a:rPr lang="en-US" altLang="ja-JP" sz="1100" b="0" i="0" baseline="0">
                    <a:effectLst/>
                  </a:rPr>
                  <a:t>)</a:t>
                </a:r>
                <a:endParaRPr lang="ja-JP" altLang="ja-JP" sz="1100" b="0">
                  <a:effectLst/>
                </a:endParaRPr>
              </a:p>
            </c:rich>
          </c:tx>
          <c:layout>
            <c:manualLayout>
              <c:xMode val="edge"/>
              <c:yMode val="edge"/>
              <c:x val="8.5364396654719239E-4"/>
              <c:y val="0.13773370900158938"/>
            </c:manualLayout>
          </c:layout>
          <c:overlay val="0"/>
        </c:title>
        <c:numFmt formatCode="#,##0_);[Red]\(#,##0\)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10091251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05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36CC8-F5F6-41F4-82CA-48E2F251F301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4BA5F-D7A3-4CE9-9064-87B2C62CC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613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36CC8-F5F6-41F4-82CA-48E2F251F301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4BA5F-D7A3-4CE9-9064-87B2C62CC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45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36CC8-F5F6-41F4-82CA-48E2F251F301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4BA5F-D7A3-4CE9-9064-87B2C62CC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9331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36CC8-F5F6-41F4-82CA-48E2F251F301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4BA5F-D7A3-4CE9-9064-87B2C62CC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4967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36CC8-F5F6-41F4-82CA-48E2F251F301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4BA5F-D7A3-4CE9-9064-87B2C62CC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5557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36CC8-F5F6-41F4-82CA-48E2F251F301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4BA5F-D7A3-4CE9-9064-87B2C62CC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180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36CC8-F5F6-41F4-82CA-48E2F251F301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4BA5F-D7A3-4CE9-9064-87B2C62CC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964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36CC8-F5F6-41F4-82CA-48E2F251F301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4BA5F-D7A3-4CE9-9064-87B2C62CC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188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36CC8-F5F6-41F4-82CA-48E2F251F301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4BA5F-D7A3-4CE9-9064-87B2C62CC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741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36CC8-F5F6-41F4-82CA-48E2F251F301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4BA5F-D7A3-4CE9-9064-87B2C62CC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7091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36CC8-F5F6-41F4-82CA-48E2F251F301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4BA5F-D7A3-4CE9-9064-87B2C62CC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611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F36CC8-F5F6-41F4-82CA-48E2F251F301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E4BA5F-D7A3-4CE9-9064-87B2C62CC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8695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02180846"/>
              </p:ext>
            </p:extLst>
          </p:nvPr>
        </p:nvGraphicFramePr>
        <p:xfrm>
          <a:off x="180000" y="540000"/>
          <a:ext cx="3077192" cy="27161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80208933"/>
              </p:ext>
            </p:extLst>
          </p:nvPr>
        </p:nvGraphicFramePr>
        <p:xfrm>
          <a:off x="3131840" y="540000"/>
          <a:ext cx="3077192" cy="27161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75369396"/>
              </p:ext>
            </p:extLst>
          </p:nvPr>
        </p:nvGraphicFramePr>
        <p:xfrm>
          <a:off x="6084000" y="540000"/>
          <a:ext cx="3077191" cy="27161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890429" y="3191874"/>
            <a:ext cx="20233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ing density (plants hill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454326" y="3789040"/>
            <a:ext cx="807811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planting density 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Zn uptake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ot biomass 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take per unit root biomass of tolerant and sensitive genotype groups at 4 WAT in the +Zn plots. Uptake was calculated from shoot Zn content minus seedling Zn content. Data are means ± standard errors (n = 4 × number of genotypes in group).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597492" y="39059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502240" y="39059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567122" y="39059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6914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B345C25C7EA3A4AB215BEDE15084701" ma:contentTypeVersion="7" ma:contentTypeDescription="Create a new document." ma:contentTypeScope="" ma:versionID="429c651f240e0d5b75d1ab5420702723">
  <xsd:schema xmlns:xsd="http://www.w3.org/2001/XMLSchema" xmlns:p="http://schemas.microsoft.com/office/2006/metadata/properties" xmlns:ns2="0312f9b2-b44e-4223-9db9-84eee2e3b8f2" targetNamespace="http://schemas.microsoft.com/office/2006/metadata/properties" ma:root="true" ma:fieldsID="43f414b2ac5dfbba7ff99640ec20a1ef" ns2:_="">
    <xsd:import namespace="0312f9b2-b44e-4223-9db9-84eee2e3b8f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0312f9b2-b44e-4223-9db9-84eee2e3b8f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0312f9b2-b44e-4223-9db9-84eee2e3b8f2">Presentation</DocumentType>
    <FileFormat xmlns="0312f9b2-b44e-4223-9db9-84eee2e3b8f2">PPTX</FileFormat>
    <StageName xmlns="0312f9b2-b44e-4223-9db9-84eee2e3b8f2">Author's Proof</StageName>
    <Checked_x0020_Out_x0020_To xmlns="0312f9b2-b44e-4223-9db9-84eee2e3b8f2">
      <UserInfo>
        <DisplayName/>
        <AccountId xsi:nil="true"/>
        <AccountType/>
      </UserInfo>
    </Checked_x0020_Out_x0020_To>
    <TitleName xmlns="0312f9b2-b44e-4223-9db9-84eee2e3b8f2">Presentation 3.pptx</TitleName>
    <DocumentId xmlns="0312f9b2-b44e-4223-9db9-84eee2e3b8f2">Presentation 3.pptx</DocumentId>
    <IsDeleted xmlns="0312f9b2-b44e-4223-9db9-84eee2e3b8f2">false</IsDeleted>
  </documentManagement>
</p:properties>
</file>

<file path=customXml/itemProps1.xml><?xml version="1.0" encoding="utf-8"?>
<ds:datastoreItem xmlns:ds="http://schemas.openxmlformats.org/officeDocument/2006/customXml" ds:itemID="{68B5C5E3-48D9-47CA-B948-7A7204995C64}"/>
</file>

<file path=customXml/itemProps2.xml><?xml version="1.0" encoding="utf-8"?>
<ds:datastoreItem xmlns:ds="http://schemas.openxmlformats.org/officeDocument/2006/customXml" ds:itemID="{27E2C214-DFEC-4DD3-A5FD-F1AC7AAED22C}"/>
</file>

<file path=customXml/itemProps3.xml><?xml version="1.0" encoding="utf-8"?>
<ds:datastoreItem xmlns:ds="http://schemas.openxmlformats.org/officeDocument/2006/customXml" ds:itemID="{7B2449DD-1BF7-4941-B2CF-BE04C1F6801F}"/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00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ias</dc:creator>
  <cp:lastModifiedBy>Matthias</cp:lastModifiedBy>
  <cp:revision>5</cp:revision>
  <dcterms:created xsi:type="dcterms:W3CDTF">2015-07-31T01:52:19Z</dcterms:created>
  <dcterms:modified xsi:type="dcterms:W3CDTF">2015-12-20T09:13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B345C25C7EA3A4AB215BEDE15084701</vt:lpwstr>
  </property>
</Properties>
</file>